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00" d="100"/>
          <a:sy n="100" d="100"/>
        </p:scale>
        <p:origin x="-3048" y="-112"/>
      </p:cViewPr>
      <p:guideLst>
        <p:guide orient="horz" pos="459"/>
        <p:guide pos="417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546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4835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4585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8400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9317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86380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07568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1760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77754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2206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6693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D5A6F-575E-7B48-94AA-3F72CA4F8635}" type="datetimeFigureOut">
              <a:rPr kumimoji="1" lang="ja-JP" altLang="en-US" smtClean="0"/>
              <a:t>17/09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58ADDF-4E56-194E-BD8B-6FE49D1176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15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61" t="27815" r="39891" b="39276"/>
          <a:stretch/>
        </p:blipFill>
        <p:spPr>
          <a:xfrm>
            <a:off x="193931" y="915973"/>
            <a:ext cx="2875561" cy="2256956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85" t="26667" r="36630" b="40825"/>
          <a:stretch/>
        </p:blipFill>
        <p:spPr>
          <a:xfrm>
            <a:off x="3732143" y="965281"/>
            <a:ext cx="2897257" cy="2229434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 rot="5400000">
            <a:off x="778325" y="3564149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ASPS-KY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 rot="5400000">
            <a:off x="573197" y="4344017"/>
            <a:ext cx="25959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Surgical material of ASPS</a:t>
            </a:r>
          </a:p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 (positive  control 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5400000">
            <a:off x="1635726" y="4040895"/>
            <a:ext cx="1805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Negative control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6929" y="306375"/>
            <a:ext cx="44397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 smtClean="0">
                <a:latin typeface="Times New Roman"/>
                <a:cs typeface="Times New Roman"/>
              </a:rPr>
              <a:t>A</a:t>
            </a:r>
            <a:endParaRPr kumimoji="1" lang="ja-JP" altLang="en-US" sz="2800" b="1" dirty="0">
              <a:latin typeface="Times New Roman"/>
              <a:cs typeface="Times New Roman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624076" y="323609"/>
            <a:ext cx="42832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b="1" dirty="0">
                <a:latin typeface="Times New Roman"/>
                <a:cs typeface="Times New Roman"/>
              </a:rPr>
              <a:t>B</a:t>
            </a:r>
            <a:endParaRPr kumimoji="1" lang="ja-JP" altLang="en-US" sz="2800" b="1" dirty="0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6929" y="1587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S1 Fig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5400000">
            <a:off x="3805240" y="3564149"/>
            <a:ext cx="851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ASPS-KY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 rot="5400000">
            <a:off x="3600112" y="4344017"/>
            <a:ext cx="25959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Surgical material of ASPS</a:t>
            </a:r>
          </a:p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 (positive  control )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 rot="5400000">
            <a:off x="4662641" y="4040895"/>
            <a:ext cx="1805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Times New Roman"/>
                <a:cs typeface="Times New Roman"/>
              </a:rPr>
              <a:t>Negative control</a:t>
            </a:r>
            <a:endParaRPr kumimoji="1" lang="ja-JP" altLang="en-US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63865480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</TotalTime>
  <Words>32</Words>
  <Application>Microsoft Macintosh PowerPoint</Application>
  <PresentationFormat>レター サイズ 8.5x11 インチ</PresentationFormat>
  <Paragraphs>1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順天堂大学整形外科学教室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末原 義之</dc:creator>
  <cp:lastModifiedBy>末原 義之</cp:lastModifiedBy>
  <cp:revision>16</cp:revision>
  <dcterms:created xsi:type="dcterms:W3CDTF">2017-05-17T17:49:27Z</dcterms:created>
  <dcterms:modified xsi:type="dcterms:W3CDTF">2017-09-15T02:26:21Z</dcterms:modified>
</cp:coreProperties>
</file>